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64" r:id="rId2"/>
    <p:sldId id="262" r:id="rId3"/>
    <p:sldId id="263" r:id="rId4"/>
  </p:sldIdLst>
  <p:sldSz cx="12192000" cy="6858000"/>
  <p:notesSz cx="6858000" cy="9144000"/>
  <p:defaultTextStyle>
    <a:defPPr>
      <a:defRPr lang="en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5884"/>
  </p:normalViewPr>
  <p:slideViewPr>
    <p:cSldViewPr snapToGrid="0">
      <p:cViewPr varScale="1">
        <p:scale>
          <a:sx n="108" d="100"/>
          <a:sy n="108" d="100"/>
        </p:scale>
        <p:origin x="59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T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286C341-5A1F-8441-8D36-54F78BCCAAAD}" type="datetimeFigureOut">
              <a:rPr lang="en-IT" smtClean="0"/>
              <a:t>11/21/2022</a:t>
            </a:fld>
            <a:endParaRPr lang="en-IT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T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8C3442A-CDA7-7248-898F-973B93EF2A82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26308505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Google Shape;117;p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18" name="Google Shape;118;p7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2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Google Shape;123;p8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24" name="Google Shape;124;p8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D696F1-39BD-EAAB-2508-29ACD2AB9AA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IT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41C7DD0-631F-E236-835B-8D50F1E6B35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4A29B2-8B2D-9C47-FD5C-FCBBDBFCF8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9D4EE-296A-2D49-B25A-8BC31A3EE1BA}" type="datetimeFigureOut">
              <a:rPr lang="en-IT" smtClean="0"/>
              <a:t>11/21/2022</a:t>
            </a:fld>
            <a:endParaRPr lang="en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CE73AA-F81A-2422-17C9-6F0346CF48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8DD03F-FE0D-490A-F7BE-2025350988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E8102-E259-6C46-804F-A2AD0D40ECE7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30722123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200810-D93F-7E9A-22B7-B711400945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IT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C856328-BF36-A89E-C0C4-68D3DF93804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77E74F-4FA9-05E6-2A65-11569C0A99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9D4EE-296A-2D49-B25A-8BC31A3EE1BA}" type="datetimeFigureOut">
              <a:rPr lang="en-IT" smtClean="0"/>
              <a:t>11/21/2022</a:t>
            </a:fld>
            <a:endParaRPr lang="en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FD740D-7FE5-E30D-792E-DAA8F1C05C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8B9718-DEC0-7856-DE3A-5F53BFA627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E8102-E259-6C46-804F-A2AD0D40ECE7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28239141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F6A31C4-17E5-CCA9-86E4-C2193060BC9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IT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503BE59-4C11-7EA0-0734-8DED8D8CD9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16D424-4A05-4B93-B4F9-4895128994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9D4EE-296A-2D49-B25A-8BC31A3EE1BA}" type="datetimeFigureOut">
              <a:rPr lang="en-IT" smtClean="0"/>
              <a:t>11/21/2022</a:t>
            </a:fld>
            <a:endParaRPr lang="en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401400-257F-E1C7-75E0-45A6667BAB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D84D52-92DB-B3EE-9A15-CE704BF058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E8102-E259-6C46-804F-A2AD0D40ECE7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5935669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E2019B-9158-6F34-D1A3-2F4AE56E90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I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67FB81C-18FE-B5E0-53D4-ED5A1D921AA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C281BA-CE4C-D033-282C-90E576B349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9D4EE-296A-2D49-B25A-8BC31A3EE1BA}" type="datetimeFigureOut">
              <a:rPr lang="en-IT" smtClean="0"/>
              <a:t>11/21/2022</a:t>
            </a:fld>
            <a:endParaRPr lang="en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ED8429-AA64-5907-FC57-47567AFCD5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53D822-31BC-3BE4-7474-A6DC7D7529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E8102-E259-6C46-804F-A2AD0D40ECE7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26482146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F09894-5193-6768-F366-DC84C6ECF3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I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FD50564-DFC7-6ED3-7CA9-DDC0610E02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E01730-8C09-0C10-0870-C06FBF7189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9D4EE-296A-2D49-B25A-8BC31A3EE1BA}" type="datetimeFigureOut">
              <a:rPr lang="en-IT" smtClean="0"/>
              <a:t>11/21/2022</a:t>
            </a:fld>
            <a:endParaRPr lang="en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7255D0-36D8-8CE5-D767-47765BA7A0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629848-12C4-35DC-CADC-DE9480DB7B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E8102-E259-6C46-804F-A2AD0D40ECE7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16105007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0B53C9-942F-E0E1-55CE-8D863EB223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I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CE23E0C-6CD2-C11F-BA97-EB86315ADDC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IT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85A8E4D-6F75-20D5-2970-B4D28CE360A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IT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4E74814-313F-3A18-4C74-10F3BA748F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9D4EE-296A-2D49-B25A-8BC31A3EE1BA}" type="datetimeFigureOut">
              <a:rPr lang="en-IT" smtClean="0"/>
              <a:t>11/21/2022</a:t>
            </a:fld>
            <a:endParaRPr lang="en-I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554B62-B52B-9F89-F22D-6580166BA1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B2EB436-5A9C-1A3F-3B3D-F85A12C34A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E8102-E259-6C46-804F-A2AD0D40ECE7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15857809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2D00AD-C223-ADF1-B72F-CF24C17658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I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503B705-7909-9A0A-A935-FB9E094030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287CF7D-348F-1D84-5035-F8EBB1328C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IT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9142911-D8B9-CB51-7609-48FADB132C9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D1A3828-3A5C-0E16-1D2E-80A28BACA1F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IT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F2029BD-40A1-8CB9-CAFC-4540F44AB8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9D4EE-296A-2D49-B25A-8BC31A3EE1BA}" type="datetimeFigureOut">
              <a:rPr lang="en-IT" smtClean="0"/>
              <a:t>11/21/2022</a:t>
            </a:fld>
            <a:endParaRPr lang="en-IT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3D58161-7ABE-A377-BF9D-A265100341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1457D7A-D4CA-71E4-20C5-130688B21C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E8102-E259-6C46-804F-A2AD0D40ECE7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15955637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E5FFE0-CFB6-9EF5-3338-0B2079A433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IT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0024E37-BC24-25A5-6A50-9CB04D00C4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9D4EE-296A-2D49-B25A-8BC31A3EE1BA}" type="datetimeFigureOut">
              <a:rPr lang="en-IT" smtClean="0"/>
              <a:t>11/21/2022</a:t>
            </a:fld>
            <a:endParaRPr lang="en-IT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46B8F76-B2E3-3F40-C4A1-3D191ABEEC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3A1CDB4-90EF-C400-DA92-98BCDDC7AC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E8102-E259-6C46-804F-A2AD0D40ECE7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2767518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7018C45-CC19-C0EE-C94C-47BE96B1FC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9D4EE-296A-2D49-B25A-8BC31A3EE1BA}" type="datetimeFigureOut">
              <a:rPr lang="en-IT" smtClean="0"/>
              <a:t>11/21/2022</a:t>
            </a:fld>
            <a:endParaRPr lang="en-IT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7DB6A8E-B6EC-F171-56B3-E24C4B9C74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0639C8D-72D0-870F-E2A3-F660C2F69E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E8102-E259-6C46-804F-A2AD0D40ECE7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29721665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79863C-A3C3-A923-7A94-128ED52EBF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I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3F2B108-1484-6604-AAC7-197F6C9D603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IT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F1748FD-1E94-5F89-799B-2829D385F88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3F0EE34-E139-0D3F-B05D-A54CF8B0DC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9D4EE-296A-2D49-B25A-8BC31A3EE1BA}" type="datetimeFigureOut">
              <a:rPr lang="en-IT" smtClean="0"/>
              <a:t>11/21/2022</a:t>
            </a:fld>
            <a:endParaRPr lang="en-I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CE3CB74-3F79-9B32-0708-4EDCD0FED6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3CBF586-D982-E49D-69F3-1C188F4E5F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E8102-E259-6C46-804F-A2AD0D40ECE7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36427795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2C8922-2406-7373-7993-7B3EC7F2C3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IT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45C1F58-6A0D-8EFF-48DF-C2AD841F2F7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T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7D6A7EB-17CC-180A-9653-FA1DF6CF4F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EEB14BF-827B-DC80-5A55-21C4C0428E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9D4EE-296A-2D49-B25A-8BC31A3EE1BA}" type="datetimeFigureOut">
              <a:rPr lang="en-IT" smtClean="0"/>
              <a:t>11/21/2022</a:t>
            </a:fld>
            <a:endParaRPr lang="en-I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66862B2-5063-10F6-77A8-F1740EC3BC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2AB0F53-2767-8EDC-B129-77B55217EA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E8102-E259-6C46-804F-A2AD0D40ECE7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42585969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8B540CA-56C3-5259-4BAA-22A1150CF9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I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6251EB9-6BCA-01FC-3450-8DBF145BC9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61DE41-8CDD-99CC-E495-2ED6EA42C27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C9D4EE-296A-2D49-B25A-8BC31A3EE1BA}" type="datetimeFigureOut">
              <a:rPr lang="en-IT" smtClean="0"/>
              <a:t>11/21/2022</a:t>
            </a:fld>
            <a:endParaRPr lang="en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A6C010-B0A2-0DE2-B871-91BF5660281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2BB058-E731-A6D5-035E-EE87E318353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FE8102-E259-6C46-804F-A2AD0D40ECE7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12645360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>
            <a:extLst>
              <a:ext uri="{FF2B5EF4-FFF2-40B4-BE49-F238E27FC236}">
                <a16:creationId xmlns:a16="http://schemas.microsoft.com/office/drawing/2014/main" id="{F01C9C80-B193-B449-8FE5-53EF866C3E4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19300" y="510831"/>
            <a:ext cx="8153400" cy="2717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Picture 4">
            <a:extLst>
              <a:ext uri="{FF2B5EF4-FFF2-40B4-BE49-F238E27FC236}">
                <a16:creationId xmlns:a16="http://schemas.microsoft.com/office/drawing/2014/main" id="{E3510879-D08E-014B-BDD6-F0BC69E662F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19300" y="3121055"/>
            <a:ext cx="8153400" cy="2717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CasellaDiTesto 3">
            <a:extLst>
              <a:ext uri="{FF2B5EF4-FFF2-40B4-BE49-F238E27FC236}">
                <a16:creationId xmlns:a16="http://schemas.microsoft.com/office/drawing/2014/main" id="{C3E8CB5F-CEAA-FC45-9A06-6BC5F6A8F828}"/>
              </a:ext>
            </a:extLst>
          </p:cNvPr>
          <p:cNvSpPr txBox="1"/>
          <p:nvPr/>
        </p:nvSpPr>
        <p:spPr>
          <a:xfrm>
            <a:off x="1027945" y="5931670"/>
            <a:ext cx="1049618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The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unnel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ot of (a) OS and (b) PFS show the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ffect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ze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ach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udy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ressed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andardized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n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fference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HR) on the x-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xis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the standard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rror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from large to small) on the y-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xis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o facilitate the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sult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erpretation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he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unnel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ots include the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dealized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unnel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ape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aded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ned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  <a:p>
            <a:pPr algn="just"/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ected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the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cluded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udies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ertical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tted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ne in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ach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ot shows the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verage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ffect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ze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  </a:t>
            </a:r>
          </a:p>
          <a:p>
            <a:pPr algn="just"/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st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the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vestigated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udies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ported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 positive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ffect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i.e.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Rs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gt;1). </a:t>
            </a:r>
          </a:p>
        </p:txBody>
      </p:sp>
    </p:spTree>
    <p:extLst>
      <p:ext uri="{BB962C8B-B14F-4D97-AF65-F5344CB8AC3E}">
        <p14:creationId xmlns:p14="http://schemas.microsoft.com/office/powerpoint/2010/main" val="17897748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0" name="Google Shape;120;p7" descr="A picture containing text&#10;&#10;Description automatically generated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609600" y="876700"/>
            <a:ext cx="10972802" cy="3657601"/>
          </a:xfrm>
          <a:prstGeom prst="rect">
            <a:avLst/>
          </a:prstGeom>
          <a:noFill/>
          <a:ln>
            <a:noFill/>
          </a:ln>
        </p:spPr>
      </p:pic>
      <p:sp>
        <p:nvSpPr>
          <p:cNvPr id="121" name="Google Shape;121;p7"/>
          <p:cNvSpPr txBox="1"/>
          <p:nvPr/>
        </p:nvSpPr>
        <p:spPr>
          <a:xfrm>
            <a:off x="1318726" y="5444413"/>
            <a:ext cx="9112899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 b="1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Arial"/>
              </a:rPr>
              <a:t>Figure S2</a:t>
            </a:r>
            <a:r>
              <a:rPr lang="it-IT" sz="1200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Arial"/>
              </a:rPr>
              <a:t>: O</a:t>
            </a:r>
            <a:r>
              <a:rPr lang="it-IT" sz="1200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verall pooled HRs comparing the high versus the low-PD-L1 values group for PFS in RCC patients.</a:t>
            </a:r>
            <a:endParaRPr sz="1200" dirty="0">
              <a:solidFill>
                <a:schemeClr val="dk1"/>
              </a:solidFill>
              <a:latin typeface="Times New Roman" panose="02020603050405020304" pitchFamily="18" charset="0"/>
              <a:ea typeface="Calibri"/>
              <a:cs typeface="Times New Roman" panose="02020603050405020304" pitchFamily="18" charset="0"/>
              <a:sym typeface="Calibri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6" name="Google Shape;126;p8" descr="A picture containing text&#10;&#10;Description automatically generated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609600" y="967150"/>
            <a:ext cx="10972802" cy="3657601"/>
          </a:xfrm>
          <a:prstGeom prst="rect">
            <a:avLst/>
          </a:prstGeom>
          <a:noFill/>
          <a:ln>
            <a:noFill/>
          </a:ln>
        </p:spPr>
      </p:pic>
      <p:sp>
        <p:nvSpPr>
          <p:cNvPr id="127" name="Google Shape;127;p8"/>
          <p:cNvSpPr txBox="1"/>
          <p:nvPr/>
        </p:nvSpPr>
        <p:spPr>
          <a:xfrm>
            <a:off x="1318726" y="5444413"/>
            <a:ext cx="9112899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200" b="1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Arial"/>
              </a:rPr>
              <a:t>Figure S3</a:t>
            </a:r>
            <a:r>
              <a:rPr lang="it-IT" sz="1200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Arial"/>
              </a:rPr>
              <a:t>: </a:t>
            </a:r>
            <a:r>
              <a:rPr lang="it-IT" sz="1200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overall pooled HRs comparing the high versus the low-PD-L1 values group for PFS in Melanoma patients.</a:t>
            </a:r>
            <a:endParaRPr sz="1200" dirty="0">
              <a:solidFill>
                <a:schemeClr val="dk1"/>
              </a:solidFill>
              <a:latin typeface="Times New Roman" panose="02020603050405020304" pitchFamily="18" charset="0"/>
              <a:ea typeface="Calibri"/>
              <a:cs typeface="Times New Roman" panose="02020603050405020304" pitchFamily="18" charset="0"/>
              <a:sym typeface="Calibri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5</Words>
  <Application>Microsoft Office PowerPoint</Application>
  <PresentationFormat>Widescreen</PresentationFormat>
  <Paragraphs>6</Paragraphs>
  <Slides>3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bio Scirocchi</dc:creator>
  <cp:lastModifiedBy>MDPI</cp:lastModifiedBy>
  <cp:revision>2</cp:revision>
  <dcterms:created xsi:type="dcterms:W3CDTF">2022-09-28T14:22:14Z</dcterms:created>
  <dcterms:modified xsi:type="dcterms:W3CDTF">2022-11-21T16:06:06Z</dcterms:modified>
</cp:coreProperties>
</file>